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60" r:id="rId5"/>
    <p:sldId id="267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DF"/>
    <a:srgbClr val="FEE2B5"/>
    <a:srgbClr val="FDC6A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9" d="100"/>
          <a:sy n="79" d="100"/>
        </p:scale>
        <p:origin x="15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rdi Llorens Baucells" userId="f739b413-3279-4660-a9e1-a4590e54fcd6" providerId="ADAL" clId="{66584B1A-EEA5-4650-BCF5-2499DDCD4B42}"/>
    <pc:docChg chg="delSld">
      <pc:chgData name="Jordi Llorens Baucells" userId="f739b413-3279-4660-a9e1-a4590e54fcd6" providerId="ADAL" clId="{66584B1A-EEA5-4650-BCF5-2499DDCD4B42}" dt="2025-07-16T12:56:43.811" v="1" actId="47"/>
      <pc:docMkLst>
        <pc:docMk/>
      </pc:docMkLst>
      <pc:sldChg chg="del">
        <pc:chgData name="Jordi Llorens Baucells" userId="f739b413-3279-4660-a9e1-a4590e54fcd6" providerId="ADAL" clId="{66584B1A-EEA5-4650-BCF5-2499DDCD4B42}" dt="2025-07-16T12:56:41.437" v="0" actId="47"/>
        <pc:sldMkLst>
          <pc:docMk/>
          <pc:sldMk cId="2879512903" sldId="261"/>
        </pc:sldMkLst>
      </pc:sldChg>
      <pc:sldChg chg="del">
        <pc:chgData name="Jordi Llorens Baucells" userId="f739b413-3279-4660-a9e1-a4590e54fcd6" providerId="ADAL" clId="{66584B1A-EEA5-4650-BCF5-2499DDCD4B42}" dt="2025-07-16T12:56:43.811" v="1" actId="47"/>
        <pc:sldMkLst>
          <pc:docMk/>
          <pc:sldMk cId="3267714864" sldId="26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a-ES"/>
              <a:t>Feu clic aquí per editar l'estil de subtítols del patr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6002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836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491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9805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4033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7072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0263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196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399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597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a-ES"/>
              <a:t>Feu clic a la icona per afegir una imat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3583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5DCD5-512F-460A-8639-8DF62A71B0EF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34D5F-D8CD-4BA1-A842-B9F0546BF7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691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Agrupa 34"/>
          <p:cNvGrpSpPr/>
          <p:nvPr/>
        </p:nvGrpSpPr>
        <p:grpSpPr>
          <a:xfrm>
            <a:off x="110579" y="1215754"/>
            <a:ext cx="6638442" cy="6316761"/>
            <a:chOff x="78680" y="1162589"/>
            <a:chExt cx="6638442" cy="6316761"/>
          </a:xfrm>
        </p:grpSpPr>
        <p:pic>
          <p:nvPicPr>
            <p:cNvPr id="34" name="Imatge 3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21657" y="4529750"/>
              <a:ext cx="3274198" cy="2949600"/>
            </a:xfrm>
            <a:prstGeom prst="rect">
              <a:avLst/>
            </a:prstGeom>
          </p:spPr>
        </p:pic>
        <p:pic>
          <p:nvPicPr>
            <p:cNvPr id="32" name="Imatge 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14136" y="1385642"/>
              <a:ext cx="3302986" cy="2954312"/>
            </a:xfrm>
            <a:prstGeom prst="rect">
              <a:avLst/>
            </a:prstGeom>
          </p:spPr>
        </p:pic>
        <p:pic>
          <p:nvPicPr>
            <p:cNvPr id="31" name="Imatge 3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8680" y="4541594"/>
              <a:ext cx="3285029" cy="2937754"/>
            </a:xfrm>
            <a:prstGeom prst="rect">
              <a:avLst/>
            </a:prstGeom>
          </p:spPr>
        </p:pic>
        <p:pic>
          <p:nvPicPr>
            <p:cNvPr id="30" name="Imatge 2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6823" y="1396276"/>
              <a:ext cx="3290085" cy="2942276"/>
            </a:xfrm>
            <a:prstGeom prst="rect">
              <a:avLst/>
            </a:prstGeom>
          </p:spPr>
        </p:pic>
        <p:sp>
          <p:nvSpPr>
            <p:cNvPr id="26" name="QuadreDeText 25"/>
            <p:cNvSpPr txBox="1"/>
            <p:nvPr/>
          </p:nvSpPr>
          <p:spPr>
            <a:xfrm>
              <a:off x="582131" y="1162589"/>
              <a:ext cx="16273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  Mouse/IDPN</a:t>
              </a:r>
            </a:p>
          </p:txBody>
        </p:sp>
        <p:sp>
          <p:nvSpPr>
            <p:cNvPr id="27" name="QuadreDeText 26"/>
            <p:cNvSpPr txBox="1"/>
            <p:nvPr/>
          </p:nvSpPr>
          <p:spPr>
            <a:xfrm>
              <a:off x="3922490" y="1162589"/>
              <a:ext cx="1388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B  Rat/STREP</a:t>
              </a:r>
            </a:p>
          </p:txBody>
        </p:sp>
        <p:sp>
          <p:nvSpPr>
            <p:cNvPr id="28" name="QuadreDeText 27"/>
            <p:cNvSpPr txBox="1"/>
            <p:nvPr/>
          </p:nvSpPr>
          <p:spPr>
            <a:xfrm>
              <a:off x="582131" y="4345279"/>
              <a:ext cx="17390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  Rat/IDPN-4wk</a:t>
              </a:r>
            </a:p>
          </p:txBody>
        </p:sp>
        <p:sp>
          <p:nvSpPr>
            <p:cNvPr id="29" name="QuadreDeText 28"/>
            <p:cNvSpPr txBox="1"/>
            <p:nvPr/>
          </p:nvSpPr>
          <p:spPr>
            <a:xfrm>
              <a:off x="3922490" y="4345279"/>
              <a:ext cx="23546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D Rat/IDPN-3wk &amp; 7wk</a:t>
              </a:r>
            </a:p>
          </p:txBody>
        </p:sp>
      </p:grpSp>
      <p:sp>
        <p:nvSpPr>
          <p:cNvPr id="36" name="QuadreDeText 35"/>
          <p:cNvSpPr txBox="1"/>
          <p:nvPr/>
        </p:nvSpPr>
        <p:spPr>
          <a:xfrm>
            <a:off x="2847944" y="440741"/>
            <a:ext cx="1473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. Fig S1. </a:t>
            </a:r>
          </a:p>
        </p:txBody>
      </p:sp>
    </p:spTree>
    <p:extLst>
      <p:ext uri="{BB962C8B-B14F-4D97-AF65-F5344CB8AC3E}">
        <p14:creationId xmlns:p14="http://schemas.microsoft.com/office/powerpoint/2010/main" val="1127957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62520" y="891860"/>
            <a:ext cx="573848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Supplementary Fig S1. Effect of </a:t>
            </a:r>
            <a:r>
              <a:rPr lang="en-GB" sz="1200" dirty="0" err="1"/>
              <a:t>subchronic</a:t>
            </a:r>
            <a:r>
              <a:rPr lang="en-GB" sz="1200" dirty="0"/>
              <a:t> </a:t>
            </a:r>
            <a:r>
              <a:rPr lang="en-GB" sz="1200" dirty="0" err="1"/>
              <a:t>otototoxicity</a:t>
            </a:r>
            <a:r>
              <a:rPr lang="en-GB" sz="1200" dirty="0"/>
              <a:t> on body weight. Graphs show the body weight of the individual animals from which the RNA was extracted for RNA-</a:t>
            </a:r>
            <a:r>
              <a:rPr lang="en-GB" sz="1200" dirty="0" err="1"/>
              <a:t>seq</a:t>
            </a:r>
            <a:r>
              <a:rPr lang="en-GB" sz="1200" dirty="0"/>
              <a:t> analysis.</a:t>
            </a:r>
          </a:p>
        </p:txBody>
      </p:sp>
    </p:spTree>
    <p:extLst>
      <p:ext uri="{BB962C8B-B14F-4D97-AF65-F5344CB8AC3E}">
        <p14:creationId xmlns:p14="http://schemas.microsoft.com/office/powerpoint/2010/main" val="11428152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Tema de l'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l'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l'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ba3f5ce-5422-4f75-82b8-6ed129aa1f2e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6118A182A8DCF4F902A14E779520E0C" ma:contentTypeVersion="18" ma:contentTypeDescription="Crear nuevo documento." ma:contentTypeScope="" ma:versionID="874c8a4d6caf68f3af6ef1b41e71762a">
  <xsd:schema xmlns:xsd="http://www.w3.org/2001/XMLSchema" xmlns:xs="http://www.w3.org/2001/XMLSchema" xmlns:p="http://schemas.microsoft.com/office/2006/metadata/properties" xmlns:ns3="1496553d-e557-4b67-917b-c9b3417b0f6a" xmlns:ns4="fba3f5ce-5422-4f75-82b8-6ed129aa1f2e" targetNamespace="http://schemas.microsoft.com/office/2006/metadata/properties" ma:root="true" ma:fieldsID="75140518b4d8078eec968c34e030fe85" ns3:_="" ns4:_="">
    <xsd:import namespace="1496553d-e557-4b67-917b-c9b3417b0f6a"/>
    <xsd:import namespace="fba3f5ce-5422-4f75-82b8-6ed129aa1f2e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LengthInSeconds" minOccurs="0"/>
                <xsd:element ref="ns4:_activity" minOccurs="0"/>
                <xsd:element ref="ns4:MediaServiceObjectDetectorVersions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96553d-e557-4b67-917b-c9b3417b0f6a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mpartido con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Detalles de uso compartido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de la sugerencia para compartir" ma:description="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ba3f5ce-5422-4f75-82b8-6ed129aa1f2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5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6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FC620FD-12FA-4C6E-A905-797EDEB882B0}">
  <ds:schemaRefs>
    <ds:schemaRef ds:uri="http://schemas.microsoft.com/office/infopath/2007/PartnerControls"/>
    <ds:schemaRef ds:uri="http://schemas.microsoft.com/office/2006/metadata/properties"/>
    <ds:schemaRef ds:uri="http://purl.org/dc/terms/"/>
    <ds:schemaRef ds:uri="http://schemas.microsoft.com/office/2006/documentManagement/types"/>
    <ds:schemaRef ds:uri="1496553d-e557-4b67-917b-c9b3417b0f6a"/>
    <ds:schemaRef ds:uri="http://schemas.openxmlformats.org/package/2006/metadata/core-properties"/>
    <ds:schemaRef ds:uri="fba3f5ce-5422-4f75-82b8-6ed129aa1f2e"/>
    <ds:schemaRef ds:uri="http://purl.org/dc/elements/1.1/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B77CD408-21F3-48FD-A415-04E71CE4444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E01A0A5-B319-49B1-A71B-E999367D8F6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496553d-e557-4b67-917b-c9b3417b0f6a"/>
    <ds:schemaRef ds:uri="fba3f5ce-5422-4f75-82b8-6ed129aa1f2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9</TotalTime>
  <Words>54</Words>
  <Application>Microsoft Office PowerPoint</Application>
  <PresentationFormat>Presentació en pantalla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3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l'Office</vt:lpstr>
      <vt:lpstr>Presentació del PowerPoint</vt:lpstr>
      <vt:lpstr>Presentació del PowerPoint</vt:lpstr>
    </vt:vector>
  </TitlesOfParts>
  <Company>Universitat de Barcelo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Jordi Llorens Baucells</dc:creator>
  <cp:lastModifiedBy>Jordi Llorens Baucells</cp:lastModifiedBy>
  <cp:revision>37</cp:revision>
  <dcterms:created xsi:type="dcterms:W3CDTF">2023-05-02T11:24:05Z</dcterms:created>
  <dcterms:modified xsi:type="dcterms:W3CDTF">2025-07-16T12:5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6118A182A8DCF4F902A14E779520E0C</vt:lpwstr>
  </property>
</Properties>
</file>